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E1846E-6634-4988-92CA-A77BB9ADCF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ABC64-F129-413B-B65E-EF15BA3121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1C645A-3210-42C4-A2FF-BC73A8E5E0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BB52CB-7D75-48F4-AF8E-03E652DAE0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BB35D6-514A-4DE3-B8BB-E9265B7136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EA17AF-FA1F-42DF-AC2E-AE7B2AD33F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58325-6E7B-4201-AD6E-FC94D0C104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861EF-E475-4795-A23B-12C43B5666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EF131-1503-41CB-8D97-E9EC01164E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2AA56-52BB-4EF5-B21C-9A5DA81EA6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8D571-9D81-4EE9-86B7-A170085E40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7D5EA-92D8-4DEA-BAFB-5FAA890927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E3299B-81AF-4574-BB66-5CC43309686F}" type="slidenum">
              <a:rPr b="0" lang="ja-JP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25600" y="685800"/>
            <a:ext cx="550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ble S1. Primers for the sequence analyses around retroviral integration si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685800" y="1143000"/>
          <a:ext cx="5143680" cy="3822480"/>
        </p:xfrm>
        <a:graphic>
          <a:graphicData uri="http://schemas.openxmlformats.org/drawingml/2006/table">
            <a:tbl>
              <a:tblPr/>
              <a:tblGrid>
                <a:gridCol w="1123920"/>
                <a:gridCol w="4019760"/>
              </a:tblGrid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imer 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quence (5’ to 3’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3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TGTGCCCGTCTGTTGTGTGACTCTGGTAAC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u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GCTGGGATTACAGGCGTGAGCCA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3-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GTGACTCTGGTAACTAGAGATCC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3-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CAACAGACGGGCACAGCTGGGAT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5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GGCTTCTTCTACCTTCTCTTGCTCACT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u-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ATCCGCCCGCCTCGGCCTCCCAAA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5-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AGTAGCCTTGTGTGTGGTAGATCC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5-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AAGAGAAGGTAGAAGAAGCCATCCG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LV3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GTGGTCTCGCTGTTCCTTGGGAGGGTC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LV3-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CTTGGGAGGGTCTCCTCTGAGTG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LV3-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GAACAGCGAGACCACGCT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-U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AATAAAGCTTGCCTTGAGTGCTTCAAGTAG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-U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TCAGTGGATATCTGATCCCTGGCCCTGGTG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7T06:29:16Z</dcterms:created>
  <dc:creator>櫻井 康晃</dc:creator>
  <dc:description/>
  <dc:language>en-US</dc:language>
  <cp:lastModifiedBy>櫻井 康晃</cp:lastModifiedBy>
  <dcterms:modified xsi:type="dcterms:W3CDTF">2009-11-15T10:07:10Z</dcterms:modified>
  <cp:revision>3</cp:revision>
  <dc:subject/>
  <dc:title>PowerPoint プレゼンテーション</dc:title>
</cp:coreProperties>
</file>